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301" r:id="rId5"/>
    <p:sldId id="303" r:id="rId6"/>
    <p:sldId id="302" r:id="rId7"/>
    <p:sldId id="277" r:id="rId8"/>
    <p:sldId id="280" r:id="rId9"/>
    <p:sldId id="281" r:id="rId10"/>
    <p:sldId id="279" r:id="rId11"/>
    <p:sldId id="278" r:id="rId1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21" d="100"/>
          <a:sy n="121" d="100"/>
        </p:scale>
        <p:origin x="15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microsoft.com/office/2016/11/relationships/changesInfo" Target="changesInfos/changesInfo1.xml"/><Relationship Id="rId2" Type="http://schemas.openxmlformats.org/officeDocument/2006/relationships/customXml" Target="../customXml/item2.xml"/><Relationship Id="rId16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theme" Target="theme/theme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acopo Boni" userId="3468928e-f576-476d-811b-ea8091bad45a" providerId="ADAL" clId="{A57800CA-4072-4B01-99D3-B58C761CB754}"/>
    <pc:docChg chg="undo custSel addSld delSld modSld">
      <pc:chgData name="Jacopo Boni" userId="3468928e-f576-476d-811b-ea8091bad45a" providerId="ADAL" clId="{A57800CA-4072-4B01-99D3-B58C761CB754}" dt="2025-07-25T13:30:17.809" v="327" actId="14100"/>
      <pc:docMkLst>
        <pc:docMk/>
      </pc:docMkLst>
      <pc:sldChg chg="modSp mod">
        <pc:chgData name="Jacopo Boni" userId="3468928e-f576-476d-811b-ea8091bad45a" providerId="ADAL" clId="{A57800CA-4072-4B01-99D3-B58C761CB754}" dt="2025-07-25T13:11:22.803" v="181" actId="14100"/>
        <pc:sldMkLst>
          <pc:docMk/>
          <pc:sldMk cId="1899656772" sldId="257"/>
        </pc:sldMkLst>
      </pc:sldChg>
      <pc:sldChg chg="addSp delSp modSp mod">
        <pc:chgData name="Jacopo Boni" userId="3468928e-f576-476d-811b-ea8091bad45a" providerId="ADAL" clId="{A57800CA-4072-4B01-99D3-B58C761CB754}" dt="2025-07-25T12:33:10.854" v="113" actId="732"/>
        <pc:sldMkLst>
          <pc:docMk/>
          <pc:sldMk cId="849156004" sldId="276"/>
        </pc:sldMkLst>
      </pc:sldChg>
      <pc:sldChg chg="addSp modSp mod">
        <pc:chgData name="Jacopo Boni" userId="3468928e-f576-476d-811b-ea8091bad45a" providerId="ADAL" clId="{A57800CA-4072-4B01-99D3-B58C761CB754}" dt="2025-07-25T13:27:02.726" v="320" actId="1076"/>
        <pc:sldMkLst>
          <pc:docMk/>
          <pc:sldMk cId="989154112" sldId="278"/>
        </pc:sldMkLst>
      </pc:sldChg>
      <pc:sldChg chg="addSp delSp modSp mod">
        <pc:chgData name="Jacopo Boni" userId="3468928e-f576-476d-811b-ea8091bad45a" providerId="ADAL" clId="{A57800CA-4072-4B01-99D3-B58C761CB754}" dt="2025-07-25T13:30:17.809" v="327" actId="14100"/>
        <pc:sldMkLst>
          <pc:docMk/>
          <pc:sldMk cId="1574192415" sldId="279"/>
        </pc:sldMkLst>
      </pc:sldChg>
      <pc:sldChg chg="addSp delSp modSp add del mod">
        <pc:chgData name="Jacopo Boni" userId="3468928e-f576-476d-811b-ea8091bad45a" providerId="ADAL" clId="{A57800CA-4072-4B01-99D3-B58C761CB754}" dt="2025-07-25T12:51:25.652" v="163" actId="478"/>
        <pc:sldMkLst>
          <pc:docMk/>
          <pc:sldMk cId="2685193683" sldId="282"/>
        </pc:sldMkLst>
      </pc:sldChg>
      <pc:sldChg chg="addSp modSp add del mod">
        <pc:chgData name="Jacopo Boni" userId="3468928e-f576-476d-811b-ea8091bad45a" providerId="ADAL" clId="{A57800CA-4072-4B01-99D3-B58C761CB754}" dt="2025-07-25T12:56:35.608" v="175" actId="1076"/>
        <pc:sldMkLst>
          <pc:docMk/>
          <pc:sldMk cId="3959166534" sldId="283"/>
        </pc:sldMkLst>
      </pc:sldChg>
      <pc:sldChg chg="addSp delSp modSp mod">
        <pc:chgData name="Jacopo Boni" userId="3468928e-f576-476d-811b-ea8091bad45a" providerId="ADAL" clId="{A57800CA-4072-4B01-99D3-B58C761CB754}" dt="2025-07-25T12:30:28.818" v="82" actId="478"/>
        <pc:sldMkLst>
          <pc:docMk/>
          <pc:sldMk cId="2388881966" sldId="286"/>
        </pc:sldMkLst>
      </pc:sldChg>
      <pc:sldChg chg="delSp modSp mod">
        <pc:chgData name="Jacopo Boni" userId="3468928e-f576-476d-811b-ea8091bad45a" providerId="ADAL" clId="{A57800CA-4072-4B01-99D3-B58C761CB754}" dt="2025-07-25T12:30:35.389" v="84" actId="478"/>
        <pc:sldMkLst>
          <pc:docMk/>
          <pc:sldMk cId="3491293808" sldId="292"/>
        </pc:sldMkLst>
      </pc:sldChg>
      <pc:sldChg chg="delSp mod">
        <pc:chgData name="Jacopo Boni" userId="3468928e-f576-476d-811b-ea8091bad45a" providerId="ADAL" clId="{A57800CA-4072-4B01-99D3-B58C761CB754}" dt="2025-07-25T12:30:33.021" v="83" actId="478"/>
        <pc:sldMkLst>
          <pc:docMk/>
          <pc:sldMk cId="1938919551" sldId="293"/>
        </pc:sldMkLst>
      </pc:sldChg>
      <pc:sldChg chg="delSp modSp mod">
        <pc:chgData name="Jacopo Boni" userId="3468928e-f576-476d-811b-ea8091bad45a" providerId="ADAL" clId="{A57800CA-4072-4B01-99D3-B58C761CB754}" dt="2025-07-25T12:30:43.190" v="85" actId="478"/>
        <pc:sldMkLst>
          <pc:docMk/>
          <pc:sldMk cId="2278150265" sldId="294"/>
        </pc:sldMkLst>
      </pc:sldChg>
      <pc:sldChg chg="addSp delSp modSp add mod">
        <pc:chgData name="Jacopo Boni" userId="3468928e-f576-476d-811b-ea8091bad45a" providerId="ADAL" clId="{A57800CA-4072-4B01-99D3-B58C761CB754}" dt="2025-07-25T12:56:18.031" v="174" actId="14100"/>
        <pc:sldMkLst>
          <pc:docMk/>
          <pc:sldMk cId="1510078259" sldId="299"/>
        </pc:sldMkLst>
      </pc:sldChg>
      <pc:sldChg chg="addSp delSp modSp add mod">
        <pc:chgData name="Jacopo Boni" userId="3468928e-f576-476d-811b-ea8091bad45a" providerId="ADAL" clId="{A57800CA-4072-4B01-99D3-B58C761CB754}" dt="2025-07-25T12:54:58.422" v="169" actId="14100"/>
        <pc:sldMkLst>
          <pc:docMk/>
          <pc:sldMk cId="1256841142" sldId="300"/>
        </pc:sldMkLst>
      </pc:sldChg>
      <pc:sldChg chg="addSp delSp modSp add mod">
        <pc:chgData name="Jacopo Boni" userId="3468928e-f576-476d-811b-ea8091bad45a" providerId="ADAL" clId="{A57800CA-4072-4B01-99D3-B58C761CB754}" dt="2025-07-25T13:17:18.484" v="257" actId="1076"/>
        <pc:sldMkLst>
          <pc:docMk/>
          <pc:sldMk cId="1296663075" sldId="301"/>
        </pc:sldMkLst>
      </pc:sldChg>
      <pc:sldChg chg="delSp modSp add mod">
        <pc:chgData name="Jacopo Boni" userId="3468928e-f576-476d-811b-ea8091bad45a" providerId="ADAL" clId="{A57800CA-4072-4B01-99D3-B58C761CB754}" dt="2025-07-25T13:16:46.474" v="250" actId="1035"/>
        <pc:sldMkLst>
          <pc:docMk/>
          <pc:sldMk cId="2571517090" sldId="302"/>
        </pc:sldMkLst>
      </pc:sldChg>
      <pc:sldChg chg="addSp delSp modSp add mod">
        <pc:chgData name="Jacopo Boni" userId="3468928e-f576-476d-811b-ea8091bad45a" providerId="ADAL" clId="{A57800CA-4072-4B01-99D3-B58C761CB754}" dt="2025-07-25T13:25:08.855" v="294" actId="1076"/>
        <pc:sldMkLst>
          <pc:docMk/>
          <pc:sldMk cId="3263583077" sldId="303"/>
        </pc:sldMkLst>
      </pc:sldChg>
    </pc:docChg>
  </pc:docChgLst>
  <pc:docChgLst>
    <pc:chgData name="Míriam Fernández González" userId="S::mfernandez@idibell.cat::352a0393-308e-4058-8495-78b481706071" providerId="AD" clId="Web-{A25DEC5B-0D96-964B-8538-CEEE1D0657B9}"/>
    <pc:docChg chg="modSld">
      <pc:chgData name="Míriam Fernández González" userId="S::mfernandez@idibell.cat::352a0393-308e-4058-8495-78b481706071" providerId="AD" clId="Web-{A25DEC5B-0D96-964B-8538-CEEE1D0657B9}" dt="2025-07-24T14:40:25.906" v="11"/>
      <pc:docMkLst>
        <pc:docMk/>
      </pc:docMkLst>
      <pc:sldChg chg="delSp modSp">
        <pc:chgData name="Míriam Fernández González" userId="S::mfernandez@idibell.cat::352a0393-308e-4058-8495-78b481706071" providerId="AD" clId="Web-{A25DEC5B-0D96-964B-8538-CEEE1D0657B9}" dt="2025-07-24T14:40:15.109" v="5" actId="20577"/>
        <pc:sldMkLst>
          <pc:docMk/>
          <pc:sldMk cId="989154112" sldId="278"/>
        </pc:sldMkLst>
      </pc:sldChg>
      <pc:sldChg chg="delSp modSp">
        <pc:chgData name="Míriam Fernández González" userId="S::mfernandez@idibell.cat::352a0393-308e-4058-8495-78b481706071" providerId="AD" clId="Web-{A25DEC5B-0D96-964B-8538-CEEE1D0657B9}" dt="2025-07-24T14:40:09.328" v="2" actId="20577"/>
        <pc:sldMkLst>
          <pc:docMk/>
          <pc:sldMk cId="1574192415" sldId="279"/>
        </pc:sldMkLst>
      </pc:sldChg>
      <pc:sldChg chg="delSp modSp">
        <pc:chgData name="Míriam Fernández González" userId="S::mfernandez@idibell.cat::352a0393-308e-4058-8495-78b481706071" providerId="AD" clId="Web-{A25DEC5B-0D96-964B-8538-CEEE1D0657B9}" dt="2025-07-24T14:40:20.016" v="8" actId="20577"/>
        <pc:sldMkLst>
          <pc:docMk/>
          <pc:sldMk cId="2685193683" sldId="282"/>
        </pc:sldMkLst>
      </pc:sldChg>
      <pc:sldChg chg="delSp modSp">
        <pc:chgData name="Míriam Fernández González" userId="S::mfernandez@idibell.cat::352a0393-308e-4058-8495-78b481706071" providerId="AD" clId="Web-{A25DEC5B-0D96-964B-8538-CEEE1D0657B9}" dt="2025-07-24T14:40:25.906" v="11"/>
        <pc:sldMkLst>
          <pc:docMk/>
          <pc:sldMk cId="3959166534" sldId="283"/>
        </pc:sldMkLst>
      </pc:sldChg>
    </pc:docChg>
  </pc:docChgLst>
  <pc:docChgLst>
    <pc:chgData clId="Web-{2078CF52-1543-3A94-1FF6-FDE5A1C808B6}"/>
    <pc:docChg chg="addSld">
      <pc:chgData name="" userId="" providerId="" clId="Web-{2078CF52-1543-3A94-1FF6-FDE5A1C808B6}" dt="2025-07-25T12:42:52.619" v="0"/>
      <pc:docMkLst>
        <pc:docMk/>
      </pc:docMkLst>
      <pc:sldChg chg="add replId">
        <pc:chgData name="" userId="" providerId="" clId="Web-{2078CF52-1543-3A94-1FF6-FDE5A1C808B6}" dt="2025-07-25T12:42:52.619" v="0"/>
        <pc:sldMkLst>
          <pc:docMk/>
          <pc:sldMk cId="3846821981" sldId="297"/>
        </pc:sldMkLst>
      </pc:sldChg>
    </pc:docChg>
  </pc:docChgLst>
  <pc:docChgLst>
    <pc:chgData name="Míriam Fernández González" userId="352a0393-308e-4058-8495-78b481706071" providerId="ADAL" clId="{6CC23B6F-D564-426D-940C-C35F10A92CC4}"/>
    <pc:docChg chg="undo custSel addSld delSld modSld sldOrd">
      <pc:chgData name="Míriam Fernández González" userId="352a0393-308e-4058-8495-78b481706071" providerId="ADAL" clId="{6CC23B6F-D564-426D-940C-C35F10A92CC4}" dt="2025-07-25T13:42:06.046" v="1944" actId="20577"/>
      <pc:docMkLst>
        <pc:docMk/>
      </pc:docMkLst>
      <pc:sldChg chg="del">
        <pc:chgData name="Míriam Fernández González" userId="352a0393-308e-4058-8495-78b481706071" providerId="ADAL" clId="{6CC23B6F-D564-426D-940C-C35F10A92CC4}" dt="2025-07-23T10:06:54.583" v="1" actId="47"/>
        <pc:sldMkLst>
          <pc:docMk/>
          <pc:sldMk cId="2406273178" sldId="256"/>
        </pc:sldMkLst>
      </pc:sldChg>
      <pc:sldChg chg="addSp delSp modSp new mod">
        <pc:chgData name="Míriam Fernández González" userId="352a0393-308e-4058-8495-78b481706071" providerId="ADAL" clId="{6CC23B6F-D564-426D-940C-C35F10A92CC4}" dt="2025-07-25T12:48:25.066" v="1673" actId="1076"/>
        <pc:sldMkLst>
          <pc:docMk/>
          <pc:sldMk cId="1899656772" sldId="257"/>
        </pc:sldMkLst>
      </pc:sldChg>
      <pc:sldChg chg="add del">
        <pc:chgData name="Míriam Fernández González" userId="352a0393-308e-4058-8495-78b481706071" providerId="ADAL" clId="{6CC23B6F-D564-426D-940C-C35F10A92CC4}" dt="2025-07-23T10:08:25.607" v="29" actId="47"/>
        <pc:sldMkLst>
          <pc:docMk/>
          <pc:sldMk cId="4080752078" sldId="258"/>
        </pc:sldMkLst>
      </pc:sldChg>
      <pc:sldChg chg="add del">
        <pc:chgData name="Míriam Fernández González" userId="352a0393-308e-4058-8495-78b481706071" providerId="ADAL" clId="{6CC23B6F-D564-426D-940C-C35F10A92CC4}" dt="2025-07-23T10:08:26.158" v="30" actId="47"/>
        <pc:sldMkLst>
          <pc:docMk/>
          <pc:sldMk cId="3580857271" sldId="259"/>
        </pc:sldMkLst>
      </pc:sldChg>
      <pc:sldChg chg="add del">
        <pc:chgData name="Míriam Fernández González" userId="352a0393-308e-4058-8495-78b481706071" providerId="ADAL" clId="{6CC23B6F-D564-426D-940C-C35F10A92CC4}" dt="2025-07-23T10:08:26.661" v="31" actId="47"/>
        <pc:sldMkLst>
          <pc:docMk/>
          <pc:sldMk cId="2234829343" sldId="260"/>
        </pc:sldMkLst>
      </pc:sldChg>
      <pc:sldChg chg="add del">
        <pc:chgData name="Míriam Fernández González" userId="352a0393-308e-4058-8495-78b481706071" providerId="ADAL" clId="{6CC23B6F-D564-426D-940C-C35F10A92CC4}" dt="2025-07-23T10:08:26.959" v="32" actId="47"/>
        <pc:sldMkLst>
          <pc:docMk/>
          <pc:sldMk cId="862921727" sldId="261"/>
        </pc:sldMkLst>
      </pc:sldChg>
      <pc:sldChg chg="add del">
        <pc:chgData name="Míriam Fernández González" userId="352a0393-308e-4058-8495-78b481706071" providerId="ADAL" clId="{6CC23B6F-D564-426D-940C-C35F10A92CC4}" dt="2025-07-23T10:08:27.211" v="33" actId="47"/>
        <pc:sldMkLst>
          <pc:docMk/>
          <pc:sldMk cId="3804607996" sldId="262"/>
        </pc:sldMkLst>
      </pc:sldChg>
      <pc:sldChg chg="add del">
        <pc:chgData name="Míriam Fernández González" userId="352a0393-308e-4058-8495-78b481706071" providerId="ADAL" clId="{6CC23B6F-D564-426D-940C-C35F10A92CC4}" dt="2025-07-23T10:08:27.431" v="34" actId="47"/>
        <pc:sldMkLst>
          <pc:docMk/>
          <pc:sldMk cId="4226813653" sldId="263"/>
        </pc:sldMkLst>
      </pc:sldChg>
      <pc:sldChg chg="add del">
        <pc:chgData name="Míriam Fernández González" userId="352a0393-308e-4058-8495-78b481706071" providerId="ADAL" clId="{6CC23B6F-D564-426D-940C-C35F10A92CC4}" dt="2025-07-23T10:08:27.626" v="35" actId="47"/>
        <pc:sldMkLst>
          <pc:docMk/>
          <pc:sldMk cId="1753621800" sldId="264"/>
        </pc:sldMkLst>
      </pc:sldChg>
      <pc:sldChg chg="add del">
        <pc:chgData name="Míriam Fernández González" userId="352a0393-308e-4058-8495-78b481706071" providerId="ADAL" clId="{6CC23B6F-D564-426D-940C-C35F10A92CC4}" dt="2025-07-23T10:08:27.807" v="36" actId="47"/>
        <pc:sldMkLst>
          <pc:docMk/>
          <pc:sldMk cId="3900698960" sldId="265"/>
        </pc:sldMkLst>
      </pc:sldChg>
      <pc:sldChg chg="add del">
        <pc:chgData name="Míriam Fernández González" userId="352a0393-308e-4058-8495-78b481706071" providerId="ADAL" clId="{6CC23B6F-D564-426D-940C-C35F10A92CC4}" dt="2025-07-23T10:08:27.980" v="37" actId="47"/>
        <pc:sldMkLst>
          <pc:docMk/>
          <pc:sldMk cId="2255315707" sldId="266"/>
        </pc:sldMkLst>
      </pc:sldChg>
      <pc:sldChg chg="add del">
        <pc:chgData name="Míriam Fernández González" userId="352a0393-308e-4058-8495-78b481706071" providerId="ADAL" clId="{6CC23B6F-D564-426D-940C-C35F10A92CC4}" dt="2025-07-23T10:08:28.184" v="38" actId="47"/>
        <pc:sldMkLst>
          <pc:docMk/>
          <pc:sldMk cId="1476492493" sldId="267"/>
        </pc:sldMkLst>
      </pc:sldChg>
      <pc:sldChg chg="add del">
        <pc:chgData name="Míriam Fernández González" userId="352a0393-308e-4058-8495-78b481706071" providerId="ADAL" clId="{6CC23B6F-D564-426D-940C-C35F10A92CC4}" dt="2025-07-23T10:08:28.466" v="39" actId="47"/>
        <pc:sldMkLst>
          <pc:docMk/>
          <pc:sldMk cId="835741156" sldId="268"/>
        </pc:sldMkLst>
      </pc:sldChg>
      <pc:sldChg chg="add del">
        <pc:chgData name="Míriam Fernández González" userId="352a0393-308e-4058-8495-78b481706071" providerId="ADAL" clId="{6CC23B6F-D564-426D-940C-C35F10A92CC4}" dt="2025-07-23T10:08:29.142" v="40" actId="47"/>
        <pc:sldMkLst>
          <pc:docMk/>
          <pc:sldMk cId="1533935708" sldId="269"/>
        </pc:sldMkLst>
      </pc:sldChg>
      <pc:sldChg chg="add del ord">
        <pc:chgData name="Míriam Fernández González" userId="352a0393-308e-4058-8495-78b481706071" providerId="ADAL" clId="{6CC23B6F-D564-426D-940C-C35F10A92CC4}" dt="2025-07-23T10:08:22.656" v="28" actId="47"/>
        <pc:sldMkLst>
          <pc:docMk/>
          <pc:sldMk cId="3361930825" sldId="270"/>
        </pc:sldMkLst>
      </pc:sldChg>
      <pc:sldChg chg="add del">
        <pc:chgData name="Míriam Fernández González" userId="352a0393-308e-4058-8495-78b481706071" providerId="ADAL" clId="{6CC23B6F-D564-426D-940C-C35F10A92CC4}" dt="2025-07-23T10:08:18.413" v="25" actId="47"/>
        <pc:sldMkLst>
          <pc:docMk/>
          <pc:sldMk cId="234280666" sldId="271"/>
        </pc:sldMkLst>
      </pc:sldChg>
      <pc:sldChg chg="addSp delSp modSp add mod">
        <pc:chgData name="Míriam Fernández González" userId="352a0393-308e-4058-8495-78b481706071" providerId="ADAL" clId="{6CC23B6F-D564-426D-940C-C35F10A92CC4}" dt="2025-07-23T15:08:24.392" v="1505" actId="1076"/>
        <pc:sldMkLst>
          <pc:docMk/>
          <pc:sldMk cId="2286362297" sldId="272"/>
        </pc:sldMkLst>
      </pc:sldChg>
      <pc:sldChg chg="addSp delSp modSp add mod">
        <pc:chgData name="Míriam Fernández González" userId="352a0393-308e-4058-8495-78b481706071" providerId="ADAL" clId="{6CC23B6F-D564-426D-940C-C35F10A92CC4}" dt="2025-07-23T10:25:05.490" v="402" actId="1076"/>
        <pc:sldMkLst>
          <pc:docMk/>
          <pc:sldMk cId="3604231316" sldId="273"/>
        </pc:sldMkLst>
      </pc:sldChg>
      <pc:sldChg chg="addSp delSp modSp add mod">
        <pc:chgData name="Míriam Fernández González" userId="352a0393-308e-4058-8495-78b481706071" providerId="ADAL" clId="{6CC23B6F-D564-426D-940C-C35F10A92CC4}" dt="2025-07-23T10:25:37.465" v="407" actId="1076"/>
        <pc:sldMkLst>
          <pc:docMk/>
          <pc:sldMk cId="2525473906" sldId="274"/>
        </pc:sldMkLst>
      </pc:sldChg>
      <pc:sldChg chg="addSp delSp modSp add mod">
        <pc:chgData name="Míriam Fernández González" userId="352a0393-308e-4058-8495-78b481706071" providerId="ADAL" clId="{6CC23B6F-D564-426D-940C-C35F10A92CC4}" dt="2025-07-23T15:09:09.219" v="1514" actId="1076"/>
        <pc:sldMkLst>
          <pc:docMk/>
          <pc:sldMk cId="98097563" sldId="275"/>
        </pc:sldMkLst>
      </pc:sldChg>
      <pc:sldChg chg="addSp delSp modSp add mod">
        <pc:chgData name="Míriam Fernández González" userId="352a0393-308e-4058-8495-78b481706071" providerId="ADAL" clId="{6CC23B6F-D564-426D-940C-C35F10A92CC4}" dt="2025-07-25T13:42:06.046" v="1944" actId="20577"/>
        <pc:sldMkLst>
          <pc:docMk/>
          <pc:sldMk cId="849156004" sldId="276"/>
        </pc:sldMkLst>
      </pc:sldChg>
      <pc:sldChg chg="addSp modSp add mod ord">
        <pc:chgData name="Míriam Fernández González" userId="352a0393-308e-4058-8495-78b481706071" providerId="ADAL" clId="{6CC23B6F-D564-426D-940C-C35F10A92CC4}" dt="2025-07-23T15:10:13.896" v="1530" actId="732"/>
        <pc:sldMkLst>
          <pc:docMk/>
          <pc:sldMk cId="631989269" sldId="277"/>
        </pc:sldMkLst>
      </pc:sldChg>
      <pc:sldChg chg="add del">
        <pc:chgData name="Míriam Fernández González" userId="352a0393-308e-4058-8495-78b481706071" providerId="ADAL" clId="{6CC23B6F-D564-426D-940C-C35F10A92CC4}" dt="2025-07-23T10:28:22.542" v="472" actId="47"/>
        <pc:sldMkLst>
          <pc:docMk/>
          <pc:sldMk cId="1700075419" sldId="277"/>
        </pc:sldMkLst>
      </pc:sldChg>
      <pc:sldChg chg="addSp delSp modSp add mod ord">
        <pc:chgData name="Míriam Fernández González" userId="352a0393-308e-4058-8495-78b481706071" providerId="ADAL" clId="{6CC23B6F-D564-426D-940C-C35F10A92CC4}" dt="2025-07-25T13:36:16.325" v="1797" actId="1076"/>
        <pc:sldMkLst>
          <pc:docMk/>
          <pc:sldMk cId="989154112" sldId="278"/>
        </pc:sldMkLst>
      </pc:sldChg>
      <pc:sldChg chg="addSp delSp modSp add mod ord">
        <pc:chgData name="Míriam Fernández González" userId="352a0393-308e-4058-8495-78b481706071" providerId="ADAL" clId="{6CC23B6F-D564-426D-940C-C35F10A92CC4}" dt="2025-07-25T13:35:38.084" v="1784" actId="1076"/>
        <pc:sldMkLst>
          <pc:docMk/>
          <pc:sldMk cId="1574192415" sldId="279"/>
        </pc:sldMkLst>
      </pc:sldChg>
      <pc:sldChg chg="addSp delSp modSp add mod ord">
        <pc:chgData name="Míriam Fernández González" userId="352a0393-308e-4058-8495-78b481706071" providerId="ADAL" clId="{6CC23B6F-D564-426D-940C-C35F10A92CC4}" dt="2025-07-23T15:11:03.884" v="1543" actId="1076"/>
        <pc:sldMkLst>
          <pc:docMk/>
          <pc:sldMk cId="3766750973" sldId="280"/>
        </pc:sldMkLst>
      </pc:sldChg>
      <pc:sldChg chg="addSp delSp modSp add mod ord">
        <pc:chgData name="Míriam Fernández González" userId="352a0393-308e-4058-8495-78b481706071" providerId="ADAL" clId="{6CC23B6F-D564-426D-940C-C35F10A92CC4}" dt="2025-07-23T15:11:18.375" v="1546" actId="1076"/>
        <pc:sldMkLst>
          <pc:docMk/>
          <pc:sldMk cId="3324629129" sldId="281"/>
        </pc:sldMkLst>
      </pc:sldChg>
      <pc:sldChg chg="addSp delSp modSp add mod ord">
        <pc:chgData name="Míriam Fernández González" userId="352a0393-308e-4058-8495-78b481706071" providerId="ADAL" clId="{6CC23B6F-D564-426D-940C-C35F10A92CC4}" dt="2025-07-25T13:38:08.500" v="1887" actId="1076"/>
        <pc:sldMkLst>
          <pc:docMk/>
          <pc:sldMk cId="2685193683" sldId="282"/>
        </pc:sldMkLst>
      </pc:sldChg>
      <pc:sldChg chg="add del">
        <pc:chgData name="Míriam Fernández González" userId="352a0393-308e-4058-8495-78b481706071" providerId="ADAL" clId="{6CC23B6F-D564-426D-940C-C35F10A92CC4}" dt="2025-07-23T10:40:15.154" v="784" actId="47"/>
        <pc:sldMkLst>
          <pc:docMk/>
          <pc:sldMk cId="3650244235" sldId="282"/>
        </pc:sldMkLst>
      </pc:sldChg>
      <pc:sldChg chg="addSp delSp modSp add mod">
        <pc:chgData name="Míriam Fernández González" userId="352a0393-308e-4058-8495-78b481706071" providerId="ADAL" clId="{6CC23B6F-D564-426D-940C-C35F10A92CC4}" dt="2025-07-25T13:38:50.567" v="1898" actId="14100"/>
        <pc:sldMkLst>
          <pc:docMk/>
          <pc:sldMk cId="3959166534" sldId="283"/>
        </pc:sldMkLst>
      </pc:sldChg>
      <pc:sldChg chg="addSp delSp modSp add mod">
        <pc:chgData name="Míriam Fernández González" userId="352a0393-308e-4058-8495-78b481706071" providerId="ADAL" clId="{6CC23B6F-D564-426D-940C-C35F10A92CC4}" dt="2025-07-23T15:06:28.343" v="1488" actId="1076"/>
        <pc:sldMkLst>
          <pc:docMk/>
          <pc:sldMk cId="640523941" sldId="284"/>
        </pc:sldMkLst>
      </pc:sldChg>
      <pc:sldChg chg="addSp delSp modSp add del mod">
        <pc:chgData name="Míriam Fernández González" userId="352a0393-308e-4058-8495-78b481706071" providerId="ADAL" clId="{6CC23B6F-D564-426D-940C-C35F10A92CC4}" dt="2025-07-23T11:07:57.119" v="1087" actId="47"/>
        <pc:sldMkLst>
          <pc:docMk/>
          <pc:sldMk cId="2552082302" sldId="285"/>
        </pc:sldMkLst>
      </pc:sldChg>
      <pc:sldChg chg="addSp delSp modSp add mod">
        <pc:chgData name="Míriam Fernández González" userId="352a0393-308e-4058-8495-78b481706071" providerId="ADAL" clId="{6CC23B6F-D564-426D-940C-C35F10A92CC4}" dt="2025-07-23T15:07:15.365" v="1494" actId="1076"/>
        <pc:sldMkLst>
          <pc:docMk/>
          <pc:sldMk cId="2388881966" sldId="286"/>
        </pc:sldMkLst>
      </pc:sldChg>
      <pc:sldChg chg="delSp modSp add del mod">
        <pc:chgData name="Míriam Fernández González" userId="352a0393-308e-4058-8495-78b481706071" providerId="ADAL" clId="{6CC23B6F-D564-426D-940C-C35F10A92CC4}" dt="2025-07-23T11:09:33.386" v="1121" actId="47"/>
        <pc:sldMkLst>
          <pc:docMk/>
          <pc:sldMk cId="872468030" sldId="287"/>
        </pc:sldMkLst>
      </pc:sldChg>
      <pc:sldChg chg="addSp delSp modSp add mod ord">
        <pc:chgData name="Míriam Fernández González" userId="352a0393-308e-4058-8495-78b481706071" providerId="ADAL" clId="{6CC23B6F-D564-426D-940C-C35F10A92CC4}" dt="2025-07-23T15:06:34.939" v="1490" actId="1076"/>
        <pc:sldMkLst>
          <pc:docMk/>
          <pc:sldMk cId="1854992774" sldId="288"/>
        </pc:sldMkLst>
      </pc:sldChg>
      <pc:sldChg chg="delSp modSp add del mod">
        <pc:chgData name="Míriam Fernández González" userId="352a0393-308e-4058-8495-78b481706071" providerId="ADAL" clId="{6CC23B6F-D564-426D-940C-C35F10A92CC4}" dt="2025-07-23T14:58:21.220" v="1349" actId="47"/>
        <pc:sldMkLst>
          <pc:docMk/>
          <pc:sldMk cId="944466747" sldId="289"/>
        </pc:sldMkLst>
      </pc:sldChg>
      <pc:sldChg chg="delSp modSp add del mod">
        <pc:chgData name="Míriam Fernández González" userId="352a0393-308e-4058-8495-78b481706071" providerId="ADAL" clId="{6CC23B6F-D564-426D-940C-C35F10A92CC4}" dt="2025-07-23T11:17:00.464" v="1307" actId="47"/>
        <pc:sldMkLst>
          <pc:docMk/>
          <pc:sldMk cId="699899518" sldId="290"/>
        </pc:sldMkLst>
      </pc:sldChg>
      <pc:sldChg chg="addSp delSp modSp add mod">
        <pc:chgData name="Míriam Fernández González" userId="352a0393-308e-4058-8495-78b481706071" providerId="ADAL" clId="{6CC23B6F-D564-426D-940C-C35F10A92CC4}" dt="2025-07-23T15:07:42.025" v="1498" actId="14100"/>
        <pc:sldMkLst>
          <pc:docMk/>
          <pc:sldMk cId="3714277399" sldId="291"/>
        </pc:sldMkLst>
      </pc:sldChg>
      <pc:sldChg chg="addSp delSp modSp add mod ord">
        <pc:chgData name="Míriam Fernández González" userId="352a0393-308e-4058-8495-78b481706071" providerId="ADAL" clId="{6CC23B6F-D564-426D-940C-C35F10A92CC4}" dt="2025-07-23T15:07:55.238" v="1499"/>
        <pc:sldMkLst>
          <pc:docMk/>
          <pc:sldMk cId="3491293808" sldId="292"/>
        </pc:sldMkLst>
      </pc:sldChg>
      <pc:sldChg chg="addSp delSp modSp add mod">
        <pc:chgData name="Míriam Fernández González" userId="352a0393-308e-4058-8495-78b481706071" providerId="ADAL" clId="{6CC23B6F-D564-426D-940C-C35F10A92CC4}" dt="2025-07-23T15:07:26.903" v="1496" actId="1076"/>
        <pc:sldMkLst>
          <pc:docMk/>
          <pc:sldMk cId="1938919551" sldId="293"/>
        </pc:sldMkLst>
      </pc:sldChg>
      <pc:sldChg chg="addSp delSp modSp add mod">
        <pc:chgData name="Míriam Fernández González" userId="352a0393-308e-4058-8495-78b481706071" providerId="ADAL" clId="{6CC23B6F-D564-426D-940C-C35F10A92CC4}" dt="2025-07-23T15:07:57.744" v="1500"/>
        <pc:sldMkLst>
          <pc:docMk/>
          <pc:sldMk cId="2278150265" sldId="294"/>
        </pc:sldMkLst>
      </pc:sldChg>
      <pc:sldChg chg="addSp delSp modSp add mod ord">
        <pc:chgData name="Míriam Fernández González" userId="352a0393-308e-4058-8495-78b481706071" providerId="ADAL" clId="{6CC23B6F-D564-426D-940C-C35F10A92CC4}" dt="2025-07-23T15:08:08.012" v="1501"/>
        <pc:sldMkLst>
          <pc:docMk/>
          <pc:sldMk cId="3333836771" sldId="295"/>
        </pc:sldMkLst>
      </pc:sldChg>
      <pc:sldChg chg="addSp delSp modSp add mod ord">
        <pc:chgData name="Míriam Fernández González" userId="352a0393-308e-4058-8495-78b481706071" providerId="ADAL" clId="{6CC23B6F-D564-426D-940C-C35F10A92CC4}" dt="2025-07-23T15:08:10.319" v="1502"/>
        <pc:sldMkLst>
          <pc:docMk/>
          <pc:sldMk cId="3104352323" sldId="296"/>
        </pc:sldMkLst>
      </pc:sldChg>
      <pc:sldChg chg="addSp delSp modSp new del mod">
        <pc:chgData name="Míriam Fernández González" userId="352a0393-308e-4058-8495-78b481706071" providerId="ADAL" clId="{6CC23B6F-D564-426D-940C-C35F10A92CC4}" dt="2025-07-23T15:02:36.537" v="1431" actId="47"/>
        <pc:sldMkLst>
          <pc:docMk/>
          <pc:sldMk cId="479128856" sldId="297"/>
        </pc:sldMkLst>
      </pc:sldChg>
      <pc:sldChg chg="addSp modSp mod">
        <pc:chgData name="Míriam Fernández González" userId="352a0393-308e-4058-8495-78b481706071" providerId="ADAL" clId="{6CC23B6F-D564-426D-940C-C35F10A92CC4}" dt="2025-07-25T12:48:07.213" v="1669" actId="1076"/>
        <pc:sldMkLst>
          <pc:docMk/>
          <pc:sldMk cId="3846821981" sldId="297"/>
        </pc:sldMkLst>
      </pc:sldChg>
      <pc:sldChg chg="addSp delSp modSp mod">
        <pc:chgData name="Míriam Fernández González" userId="352a0393-308e-4058-8495-78b481706071" providerId="ADAL" clId="{6CC23B6F-D564-426D-940C-C35F10A92CC4}" dt="2025-07-25T12:48:34.066" v="1678" actId="1036"/>
        <pc:sldMkLst>
          <pc:docMk/>
          <pc:sldMk cId="3507912059" sldId="298"/>
        </pc:sldMkLst>
      </pc:sldChg>
      <pc:sldChg chg="addSp delSp modSp mod">
        <pc:chgData name="Míriam Fernández González" userId="352a0393-308e-4058-8495-78b481706071" providerId="ADAL" clId="{6CC23B6F-D564-426D-940C-C35F10A92CC4}" dt="2025-07-25T13:39:30.415" v="1907" actId="1076"/>
        <pc:sldMkLst>
          <pc:docMk/>
          <pc:sldMk cId="1510078259" sldId="299"/>
        </pc:sldMkLst>
      </pc:sldChg>
      <pc:sldChg chg="addSp delSp modSp mod">
        <pc:chgData name="Míriam Fernández González" userId="352a0393-308e-4058-8495-78b481706071" providerId="ADAL" clId="{6CC23B6F-D564-426D-940C-C35F10A92CC4}" dt="2025-07-25T13:40:05.751" v="1930" actId="1036"/>
        <pc:sldMkLst>
          <pc:docMk/>
          <pc:sldMk cId="1256841142" sldId="300"/>
        </pc:sldMkLst>
      </pc:sldChg>
      <pc:sldChg chg="modSp mod">
        <pc:chgData name="Míriam Fernández González" userId="352a0393-308e-4058-8495-78b481706071" providerId="ADAL" clId="{6CC23B6F-D564-426D-940C-C35F10A92CC4}" dt="2025-07-25T13:33:06.576" v="1682" actId="20577"/>
        <pc:sldMkLst>
          <pc:docMk/>
          <pc:sldMk cId="1296663075" sldId="301"/>
        </pc:sldMkLst>
      </pc:sldChg>
      <pc:sldChg chg="modSp mod">
        <pc:chgData name="Míriam Fernández González" userId="352a0393-308e-4058-8495-78b481706071" providerId="ADAL" clId="{6CC23B6F-D564-426D-940C-C35F10A92CC4}" dt="2025-07-25T13:33:37.413" v="1694" actId="20577"/>
        <pc:sldMkLst>
          <pc:docMk/>
          <pc:sldMk cId="2571517090" sldId="302"/>
        </pc:sldMkLst>
      </pc:sldChg>
      <pc:sldChg chg="modSp mod">
        <pc:chgData name="Míriam Fernández González" userId="352a0393-308e-4058-8495-78b481706071" providerId="ADAL" clId="{6CC23B6F-D564-426D-940C-C35F10A92CC4}" dt="2025-07-25T13:33:26.110" v="1690" actId="20577"/>
        <pc:sldMkLst>
          <pc:docMk/>
          <pc:sldMk cId="3263583077" sldId="303"/>
        </pc:sldMkLst>
      </pc:sldChg>
    </pc:docChg>
  </pc:docChgLst>
  <pc:docChgLst>
    <pc:chgData name="Míriam Fernández González" userId="S::mfernandez@idibell.cat::352a0393-308e-4058-8495-78b481706071" providerId="AD" clId="Web-{98EE4D30-4875-04A6-BF8A-D2A056950045}"/>
    <pc:docChg chg="modSld">
      <pc:chgData name="Míriam Fernández González" userId="S::mfernandez@idibell.cat::352a0393-308e-4058-8495-78b481706071" providerId="AD" clId="Web-{98EE4D30-4875-04A6-BF8A-D2A056950045}" dt="2025-07-25T13:30:24.917" v="14" actId="1076"/>
      <pc:docMkLst>
        <pc:docMk/>
      </pc:docMkLst>
      <pc:sldChg chg="modSp">
        <pc:chgData name="Míriam Fernández González" userId="S::mfernandez@idibell.cat::352a0393-308e-4058-8495-78b481706071" providerId="AD" clId="Web-{98EE4D30-4875-04A6-BF8A-D2A056950045}" dt="2025-07-25T12:54:33.628" v="0" actId="1076"/>
        <pc:sldMkLst>
          <pc:docMk/>
          <pc:sldMk cId="3604231316" sldId="273"/>
        </pc:sldMkLst>
      </pc:sldChg>
      <pc:sldChg chg="addSp delSp modSp">
        <pc:chgData name="Míriam Fernández González" userId="S::mfernandez@idibell.cat::352a0393-308e-4058-8495-78b481706071" providerId="AD" clId="Web-{98EE4D30-4875-04A6-BF8A-D2A056950045}" dt="2025-07-25T13:30:24.917" v="14" actId="1076"/>
        <pc:sldMkLst>
          <pc:docMk/>
          <pc:sldMk cId="2685193683" sldId="282"/>
        </pc:sldMkLst>
      </pc:sldChg>
    </pc:docChg>
  </pc:docChgLst>
  <pc:docChgLst>
    <pc:chgData name="Jacopo Boni" userId="3468928e-f576-476d-811b-ea8091bad45a" providerId="ADAL" clId="{F8328929-8069-4A27-BC10-04899D47FBC5}"/>
    <pc:docChg chg="delSld">
      <pc:chgData name="Jacopo Boni" userId="3468928e-f576-476d-811b-ea8091bad45a" providerId="ADAL" clId="{F8328929-8069-4A27-BC10-04899D47FBC5}" dt="2025-09-08T15:15:14.751" v="1" actId="47"/>
      <pc:docMkLst>
        <pc:docMk/>
      </pc:docMkLst>
      <pc:sldChg chg="del">
        <pc:chgData name="Jacopo Boni" userId="3468928e-f576-476d-811b-ea8091bad45a" providerId="ADAL" clId="{F8328929-8069-4A27-BC10-04899D47FBC5}" dt="2025-09-08T15:15:04.216" v="0" actId="47"/>
        <pc:sldMkLst>
          <pc:docMk/>
          <pc:sldMk cId="1899656772" sldId="257"/>
        </pc:sldMkLst>
      </pc:sldChg>
      <pc:sldChg chg="del">
        <pc:chgData name="Jacopo Boni" userId="3468928e-f576-476d-811b-ea8091bad45a" providerId="ADAL" clId="{F8328929-8069-4A27-BC10-04899D47FBC5}" dt="2025-09-08T15:15:04.216" v="0" actId="47"/>
        <pc:sldMkLst>
          <pc:docMk/>
          <pc:sldMk cId="2286362297" sldId="272"/>
        </pc:sldMkLst>
      </pc:sldChg>
      <pc:sldChg chg="del">
        <pc:chgData name="Jacopo Boni" userId="3468928e-f576-476d-811b-ea8091bad45a" providerId="ADAL" clId="{F8328929-8069-4A27-BC10-04899D47FBC5}" dt="2025-09-08T15:15:04.216" v="0" actId="47"/>
        <pc:sldMkLst>
          <pc:docMk/>
          <pc:sldMk cId="3604231316" sldId="273"/>
        </pc:sldMkLst>
      </pc:sldChg>
      <pc:sldChg chg="del">
        <pc:chgData name="Jacopo Boni" userId="3468928e-f576-476d-811b-ea8091bad45a" providerId="ADAL" clId="{F8328929-8069-4A27-BC10-04899D47FBC5}" dt="2025-09-08T15:15:04.216" v="0" actId="47"/>
        <pc:sldMkLst>
          <pc:docMk/>
          <pc:sldMk cId="2525473906" sldId="274"/>
        </pc:sldMkLst>
      </pc:sldChg>
      <pc:sldChg chg="del">
        <pc:chgData name="Jacopo Boni" userId="3468928e-f576-476d-811b-ea8091bad45a" providerId="ADAL" clId="{F8328929-8069-4A27-BC10-04899D47FBC5}" dt="2025-09-08T15:15:04.216" v="0" actId="47"/>
        <pc:sldMkLst>
          <pc:docMk/>
          <pc:sldMk cId="98097563" sldId="275"/>
        </pc:sldMkLst>
      </pc:sldChg>
      <pc:sldChg chg="del">
        <pc:chgData name="Jacopo Boni" userId="3468928e-f576-476d-811b-ea8091bad45a" providerId="ADAL" clId="{F8328929-8069-4A27-BC10-04899D47FBC5}" dt="2025-09-08T15:15:04.216" v="0" actId="47"/>
        <pc:sldMkLst>
          <pc:docMk/>
          <pc:sldMk cId="849156004" sldId="276"/>
        </pc:sldMkLst>
      </pc:sldChg>
      <pc:sldChg chg="del">
        <pc:chgData name="Jacopo Boni" userId="3468928e-f576-476d-811b-ea8091bad45a" providerId="ADAL" clId="{F8328929-8069-4A27-BC10-04899D47FBC5}" dt="2025-09-08T15:15:14.751" v="1" actId="47"/>
        <pc:sldMkLst>
          <pc:docMk/>
          <pc:sldMk cId="2685193683" sldId="282"/>
        </pc:sldMkLst>
      </pc:sldChg>
      <pc:sldChg chg="del">
        <pc:chgData name="Jacopo Boni" userId="3468928e-f576-476d-811b-ea8091bad45a" providerId="ADAL" clId="{F8328929-8069-4A27-BC10-04899D47FBC5}" dt="2025-09-08T15:15:14.751" v="1" actId="47"/>
        <pc:sldMkLst>
          <pc:docMk/>
          <pc:sldMk cId="3959166534" sldId="283"/>
        </pc:sldMkLst>
      </pc:sldChg>
      <pc:sldChg chg="del">
        <pc:chgData name="Jacopo Boni" userId="3468928e-f576-476d-811b-ea8091bad45a" providerId="ADAL" clId="{F8328929-8069-4A27-BC10-04899D47FBC5}" dt="2025-09-08T15:15:04.216" v="0" actId="47"/>
        <pc:sldMkLst>
          <pc:docMk/>
          <pc:sldMk cId="640523941" sldId="284"/>
        </pc:sldMkLst>
      </pc:sldChg>
      <pc:sldChg chg="del">
        <pc:chgData name="Jacopo Boni" userId="3468928e-f576-476d-811b-ea8091bad45a" providerId="ADAL" clId="{F8328929-8069-4A27-BC10-04899D47FBC5}" dt="2025-09-08T15:15:04.216" v="0" actId="47"/>
        <pc:sldMkLst>
          <pc:docMk/>
          <pc:sldMk cId="2388881966" sldId="286"/>
        </pc:sldMkLst>
      </pc:sldChg>
      <pc:sldChg chg="del">
        <pc:chgData name="Jacopo Boni" userId="3468928e-f576-476d-811b-ea8091bad45a" providerId="ADAL" clId="{F8328929-8069-4A27-BC10-04899D47FBC5}" dt="2025-09-08T15:15:04.216" v="0" actId="47"/>
        <pc:sldMkLst>
          <pc:docMk/>
          <pc:sldMk cId="1854992774" sldId="288"/>
        </pc:sldMkLst>
      </pc:sldChg>
      <pc:sldChg chg="del">
        <pc:chgData name="Jacopo Boni" userId="3468928e-f576-476d-811b-ea8091bad45a" providerId="ADAL" clId="{F8328929-8069-4A27-BC10-04899D47FBC5}" dt="2025-09-08T15:15:04.216" v="0" actId="47"/>
        <pc:sldMkLst>
          <pc:docMk/>
          <pc:sldMk cId="3714277399" sldId="291"/>
        </pc:sldMkLst>
      </pc:sldChg>
      <pc:sldChg chg="del">
        <pc:chgData name="Jacopo Boni" userId="3468928e-f576-476d-811b-ea8091bad45a" providerId="ADAL" clId="{F8328929-8069-4A27-BC10-04899D47FBC5}" dt="2025-09-08T15:15:04.216" v="0" actId="47"/>
        <pc:sldMkLst>
          <pc:docMk/>
          <pc:sldMk cId="3491293808" sldId="292"/>
        </pc:sldMkLst>
      </pc:sldChg>
      <pc:sldChg chg="del">
        <pc:chgData name="Jacopo Boni" userId="3468928e-f576-476d-811b-ea8091bad45a" providerId="ADAL" clId="{F8328929-8069-4A27-BC10-04899D47FBC5}" dt="2025-09-08T15:15:04.216" v="0" actId="47"/>
        <pc:sldMkLst>
          <pc:docMk/>
          <pc:sldMk cId="1938919551" sldId="293"/>
        </pc:sldMkLst>
      </pc:sldChg>
      <pc:sldChg chg="del">
        <pc:chgData name="Jacopo Boni" userId="3468928e-f576-476d-811b-ea8091bad45a" providerId="ADAL" clId="{F8328929-8069-4A27-BC10-04899D47FBC5}" dt="2025-09-08T15:15:04.216" v="0" actId="47"/>
        <pc:sldMkLst>
          <pc:docMk/>
          <pc:sldMk cId="2278150265" sldId="294"/>
        </pc:sldMkLst>
      </pc:sldChg>
      <pc:sldChg chg="del">
        <pc:chgData name="Jacopo Boni" userId="3468928e-f576-476d-811b-ea8091bad45a" providerId="ADAL" clId="{F8328929-8069-4A27-BC10-04899D47FBC5}" dt="2025-09-08T15:15:04.216" v="0" actId="47"/>
        <pc:sldMkLst>
          <pc:docMk/>
          <pc:sldMk cId="3333836771" sldId="295"/>
        </pc:sldMkLst>
      </pc:sldChg>
      <pc:sldChg chg="del">
        <pc:chgData name="Jacopo Boni" userId="3468928e-f576-476d-811b-ea8091bad45a" providerId="ADAL" clId="{F8328929-8069-4A27-BC10-04899D47FBC5}" dt="2025-09-08T15:15:04.216" v="0" actId="47"/>
        <pc:sldMkLst>
          <pc:docMk/>
          <pc:sldMk cId="3104352323" sldId="296"/>
        </pc:sldMkLst>
      </pc:sldChg>
      <pc:sldChg chg="del">
        <pc:chgData name="Jacopo Boni" userId="3468928e-f576-476d-811b-ea8091bad45a" providerId="ADAL" clId="{F8328929-8069-4A27-BC10-04899D47FBC5}" dt="2025-09-08T15:15:04.216" v="0" actId="47"/>
        <pc:sldMkLst>
          <pc:docMk/>
          <pc:sldMk cId="3846821981" sldId="297"/>
        </pc:sldMkLst>
      </pc:sldChg>
      <pc:sldChg chg="del">
        <pc:chgData name="Jacopo Boni" userId="3468928e-f576-476d-811b-ea8091bad45a" providerId="ADAL" clId="{F8328929-8069-4A27-BC10-04899D47FBC5}" dt="2025-09-08T15:15:04.216" v="0" actId="47"/>
        <pc:sldMkLst>
          <pc:docMk/>
          <pc:sldMk cId="3507912059" sldId="298"/>
        </pc:sldMkLst>
      </pc:sldChg>
      <pc:sldChg chg="del">
        <pc:chgData name="Jacopo Boni" userId="3468928e-f576-476d-811b-ea8091bad45a" providerId="ADAL" clId="{F8328929-8069-4A27-BC10-04899D47FBC5}" dt="2025-09-08T15:15:14.751" v="1" actId="47"/>
        <pc:sldMkLst>
          <pc:docMk/>
          <pc:sldMk cId="1510078259" sldId="299"/>
        </pc:sldMkLst>
      </pc:sldChg>
      <pc:sldChg chg="del">
        <pc:chgData name="Jacopo Boni" userId="3468928e-f576-476d-811b-ea8091bad45a" providerId="ADAL" clId="{F8328929-8069-4A27-BC10-04899D47FBC5}" dt="2025-09-08T15:15:14.751" v="1" actId="47"/>
        <pc:sldMkLst>
          <pc:docMk/>
          <pc:sldMk cId="1256841142" sldId="300"/>
        </pc:sldMkLst>
      </pc:sldChg>
    </pc:docChg>
  </pc:docChgLst>
  <pc:docChgLst>
    <pc:chgData name="Míriam Fernández González" userId="S::mfernandez@idibell.cat::352a0393-308e-4058-8495-78b481706071" providerId="AD" clId="Web-{2078CF52-1543-3A94-1FF6-FDE5A1C808B6}"/>
    <pc:docChg chg="addSld modSld sldOrd">
      <pc:chgData name="Míriam Fernández González" userId="S::mfernandez@idibell.cat::352a0393-308e-4058-8495-78b481706071" providerId="AD" clId="Web-{2078CF52-1543-3A94-1FF6-FDE5A1C808B6}" dt="2025-07-25T12:43:24.933" v="2"/>
      <pc:docMkLst>
        <pc:docMk/>
      </pc:docMkLst>
      <pc:sldChg chg="addSp modSp ord">
        <pc:chgData name="Míriam Fernández González" userId="S::mfernandez@idibell.cat::352a0393-308e-4058-8495-78b481706071" providerId="AD" clId="Web-{2078CF52-1543-3A94-1FF6-FDE5A1C808B6}" dt="2025-07-25T12:43:24.933" v="2"/>
        <pc:sldMkLst>
          <pc:docMk/>
          <pc:sldMk cId="1899656772" sldId="257"/>
        </pc:sldMkLst>
      </pc:sldChg>
      <pc:sldChg chg="add replId">
        <pc:chgData name="Míriam Fernández González" userId="S::mfernandez@idibell.cat::352a0393-308e-4058-8495-78b481706071" providerId="AD" clId="Web-{2078CF52-1543-3A94-1FF6-FDE5A1C808B6}" dt="2025-07-25T12:42:53.666" v="0"/>
        <pc:sldMkLst>
          <pc:docMk/>
          <pc:sldMk cId="3507912059" sldId="298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881914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418632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150962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98174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397005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790298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23942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306586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823756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604498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36035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331189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svg"/><Relationship Id="rId4" Type="http://schemas.openxmlformats.org/officeDocument/2006/relationships/image" Target="../media/image9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sv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BD31E57-B222-9125-84AF-BCD5730E889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Imagen 12" descr="Imagen que contiene tabla, hombre, cocina, refrigerador&#10;&#10;El contenido generado por IA puede ser incorrecto.">
            <a:extLst>
              <a:ext uri="{FF2B5EF4-FFF2-40B4-BE49-F238E27FC236}">
                <a16:creationId xmlns:a16="http://schemas.microsoft.com/office/drawing/2014/main" id="{C6BC89A8-4D83-8DF2-65F0-E77C8DFDF40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6145" y="936945"/>
            <a:ext cx="7200000" cy="5236364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EDF75652-0655-B960-621F-7420FEBAAB00}"/>
              </a:ext>
            </a:extLst>
          </p:cNvPr>
          <p:cNvSpPr txBox="1"/>
          <p:nvPr/>
        </p:nvSpPr>
        <p:spPr>
          <a:xfrm>
            <a:off x="370936" y="336430"/>
            <a:ext cx="444352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/>
              <a:t>4A</a:t>
            </a:r>
          </a:p>
        </p:txBody>
      </p:sp>
      <p:sp>
        <p:nvSpPr>
          <p:cNvPr id="5" name="Rectángulo 4">
            <a:extLst>
              <a:ext uri="{FF2B5EF4-FFF2-40B4-BE49-F238E27FC236}">
                <a16:creationId xmlns:a16="http://schemas.microsoft.com/office/drawing/2014/main" id="{AEEF26E1-CF4F-1F14-35F9-8410FD01EFFF}"/>
              </a:ext>
            </a:extLst>
          </p:cNvPr>
          <p:cNvSpPr/>
          <p:nvPr/>
        </p:nvSpPr>
        <p:spPr>
          <a:xfrm>
            <a:off x="4270515" y="2336571"/>
            <a:ext cx="3390673" cy="537258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C68DEE67-4098-2B9B-8834-6AB56D2C58D3}"/>
              </a:ext>
            </a:extLst>
          </p:cNvPr>
          <p:cNvSpPr txBox="1"/>
          <p:nvPr/>
        </p:nvSpPr>
        <p:spPr>
          <a:xfrm>
            <a:off x="9572595" y="2420534"/>
            <a:ext cx="1492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solidFill>
                  <a:srgbClr val="FF0000"/>
                </a:solidFill>
              </a:rPr>
              <a:t>FLAG-FGFR1</a:t>
            </a:r>
          </a:p>
        </p:txBody>
      </p:sp>
      <p:pic>
        <p:nvPicPr>
          <p:cNvPr id="10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ED831C83-B70F-3DD5-FE79-A8DE84134A6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51" t="7508" r="34356" b="40814"/>
          <a:stretch>
            <a:fillRect/>
          </a:stretch>
        </p:blipFill>
        <p:spPr bwMode="auto">
          <a:xfrm>
            <a:off x="2088234" y="2091863"/>
            <a:ext cx="1955831" cy="267427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CuadroTexto 10">
            <a:extLst>
              <a:ext uri="{FF2B5EF4-FFF2-40B4-BE49-F238E27FC236}">
                <a16:creationId xmlns:a16="http://schemas.microsoft.com/office/drawing/2014/main" id="{8E5FDD60-5DD3-2014-64DF-ACC83DB45758}"/>
              </a:ext>
            </a:extLst>
          </p:cNvPr>
          <p:cNvSpPr txBox="1"/>
          <p:nvPr/>
        </p:nvSpPr>
        <p:spPr>
          <a:xfrm rot="16200000">
            <a:off x="5353862" y="132703"/>
            <a:ext cx="994451" cy="33906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WT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N546K 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N546K-R661P  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K656E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K656E-R661P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R661P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D218DA7A-E755-8559-CC4E-CAE0442643FD}"/>
              </a:ext>
            </a:extLst>
          </p:cNvPr>
          <p:cNvSpPr txBox="1"/>
          <p:nvPr/>
        </p:nvSpPr>
        <p:spPr>
          <a:xfrm>
            <a:off x="5585630" y="961482"/>
            <a:ext cx="957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solidFill>
                  <a:srgbClr val="FF0000"/>
                </a:solidFill>
              </a:rPr>
              <a:t>Baf</a:t>
            </a:r>
            <a:r>
              <a:rPr lang="en-US" b="1" dirty="0">
                <a:solidFill>
                  <a:srgbClr val="FF0000"/>
                </a:solidFill>
              </a:rPr>
              <a:t> 24h</a:t>
            </a:r>
          </a:p>
        </p:txBody>
      </p:sp>
    </p:spTree>
    <p:extLst>
      <p:ext uri="{BB962C8B-B14F-4D97-AF65-F5344CB8AC3E}">
        <p14:creationId xmlns:p14="http://schemas.microsoft.com/office/powerpoint/2010/main" val="12966630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0FB5055-8E5B-861F-9DA8-DD615ABEF4D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 descr="Imagen que contiene interior, aparato, cocina, microondas&#10;&#10;El contenido generado por IA puede ser incorrecto.">
            <a:extLst>
              <a:ext uri="{FF2B5EF4-FFF2-40B4-BE49-F238E27FC236}">
                <a16:creationId xmlns:a16="http://schemas.microsoft.com/office/drawing/2014/main" id="{2FCC3B70-0305-1E52-84FC-B3EE2B3F1F5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7021" y="810818"/>
            <a:ext cx="7200000" cy="5236364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713D7C7F-A374-20A6-3319-7AF3060C8AFD}"/>
              </a:ext>
            </a:extLst>
          </p:cNvPr>
          <p:cNvSpPr txBox="1"/>
          <p:nvPr/>
        </p:nvSpPr>
        <p:spPr>
          <a:xfrm>
            <a:off x="370936" y="336430"/>
            <a:ext cx="444352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/>
              <a:t>4A</a:t>
            </a:r>
          </a:p>
        </p:txBody>
      </p:sp>
      <p:sp>
        <p:nvSpPr>
          <p:cNvPr id="5" name="Rectángulo 4">
            <a:extLst>
              <a:ext uri="{FF2B5EF4-FFF2-40B4-BE49-F238E27FC236}">
                <a16:creationId xmlns:a16="http://schemas.microsoft.com/office/drawing/2014/main" id="{1C1C052F-B9CE-E482-FFDC-961579EF719D}"/>
              </a:ext>
            </a:extLst>
          </p:cNvPr>
          <p:cNvSpPr/>
          <p:nvPr/>
        </p:nvSpPr>
        <p:spPr>
          <a:xfrm>
            <a:off x="4282872" y="3818499"/>
            <a:ext cx="3390673" cy="537258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D4275B54-C1D1-E5A1-41BA-C9FE95CA5384}"/>
              </a:ext>
            </a:extLst>
          </p:cNvPr>
          <p:cNvSpPr txBox="1"/>
          <p:nvPr/>
        </p:nvSpPr>
        <p:spPr>
          <a:xfrm>
            <a:off x="9584952" y="3902462"/>
            <a:ext cx="9994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solidFill>
                  <a:srgbClr val="FF0000"/>
                </a:solidFill>
              </a:rPr>
              <a:t>pFGFR1</a:t>
            </a:r>
          </a:p>
        </p:txBody>
      </p:sp>
      <p:pic>
        <p:nvPicPr>
          <p:cNvPr id="10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A5EECE26-008D-C817-F017-A218A7FE254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51" t="7508" r="34356" b="40814"/>
          <a:stretch>
            <a:fillRect/>
          </a:stretch>
        </p:blipFill>
        <p:spPr bwMode="auto">
          <a:xfrm>
            <a:off x="1831778" y="3573791"/>
            <a:ext cx="1955831" cy="267427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CuadroTexto 10">
            <a:extLst>
              <a:ext uri="{FF2B5EF4-FFF2-40B4-BE49-F238E27FC236}">
                <a16:creationId xmlns:a16="http://schemas.microsoft.com/office/drawing/2014/main" id="{C9AED726-DA69-F207-E642-0A00DC2A6D51}"/>
              </a:ext>
            </a:extLst>
          </p:cNvPr>
          <p:cNvSpPr txBox="1"/>
          <p:nvPr/>
        </p:nvSpPr>
        <p:spPr>
          <a:xfrm rot="16200000">
            <a:off x="5366219" y="1614631"/>
            <a:ext cx="994451" cy="33906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WT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N546K 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N546K-R661P  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K656E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K656E-R661P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R661P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7AA0EE2D-F433-6600-7CC5-DE19396F2329}"/>
              </a:ext>
            </a:extLst>
          </p:cNvPr>
          <p:cNvSpPr txBox="1"/>
          <p:nvPr/>
        </p:nvSpPr>
        <p:spPr>
          <a:xfrm>
            <a:off x="5597987" y="2443410"/>
            <a:ext cx="957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solidFill>
                  <a:srgbClr val="FF0000"/>
                </a:solidFill>
              </a:rPr>
              <a:t>Baf</a:t>
            </a:r>
            <a:r>
              <a:rPr lang="en-US" b="1" dirty="0">
                <a:solidFill>
                  <a:srgbClr val="FF0000"/>
                </a:solidFill>
              </a:rPr>
              <a:t> 24h</a:t>
            </a:r>
          </a:p>
        </p:txBody>
      </p:sp>
    </p:spTree>
    <p:extLst>
      <p:ext uri="{BB962C8B-B14F-4D97-AF65-F5344CB8AC3E}">
        <p14:creationId xmlns:p14="http://schemas.microsoft.com/office/powerpoint/2010/main" val="32635830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46F8929-DA7A-0F07-D5A3-F6476A346A6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Imagen 15" descr="Texto&#10;&#10;El contenido generado por IA puede ser incorrecto.">
            <a:extLst>
              <a:ext uri="{FF2B5EF4-FFF2-40B4-BE49-F238E27FC236}">
                <a16:creationId xmlns:a16="http://schemas.microsoft.com/office/drawing/2014/main" id="{E9596CAF-A764-7E40-FBF6-737B35AC648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6545" y="961482"/>
            <a:ext cx="7200000" cy="5236364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984E7A27-789C-0A5F-E53C-EEDC5E6B0067}"/>
              </a:ext>
            </a:extLst>
          </p:cNvPr>
          <p:cNvSpPr txBox="1"/>
          <p:nvPr/>
        </p:nvSpPr>
        <p:spPr>
          <a:xfrm>
            <a:off x="370936" y="336430"/>
            <a:ext cx="444352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/>
              <a:t>4A</a:t>
            </a:r>
          </a:p>
        </p:txBody>
      </p:sp>
      <p:sp>
        <p:nvSpPr>
          <p:cNvPr id="5" name="Rectángulo 4">
            <a:extLst>
              <a:ext uri="{FF2B5EF4-FFF2-40B4-BE49-F238E27FC236}">
                <a16:creationId xmlns:a16="http://schemas.microsoft.com/office/drawing/2014/main" id="{431F2A1E-DB23-B20D-A0DC-D48878111BEC}"/>
              </a:ext>
            </a:extLst>
          </p:cNvPr>
          <p:cNvSpPr/>
          <p:nvPr/>
        </p:nvSpPr>
        <p:spPr>
          <a:xfrm>
            <a:off x="4155751" y="4051343"/>
            <a:ext cx="3390673" cy="537258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5FE62C94-F5CD-6748-E60D-C150B890B404}"/>
              </a:ext>
            </a:extLst>
          </p:cNvPr>
          <p:cNvSpPr txBox="1"/>
          <p:nvPr/>
        </p:nvSpPr>
        <p:spPr>
          <a:xfrm>
            <a:off x="9839610" y="4135306"/>
            <a:ext cx="9619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solidFill>
                  <a:srgbClr val="FF0000"/>
                </a:solidFill>
              </a:rPr>
              <a:t>Tubulin</a:t>
            </a:r>
          </a:p>
        </p:txBody>
      </p:sp>
      <p:pic>
        <p:nvPicPr>
          <p:cNvPr id="10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7F4B11E4-27EA-89E1-7C32-D4E342A778B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51" t="7508" r="34356" b="40814"/>
          <a:stretch>
            <a:fillRect/>
          </a:stretch>
        </p:blipFill>
        <p:spPr bwMode="auto">
          <a:xfrm>
            <a:off x="1284762" y="1840220"/>
            <a:ext cx="2526211" cy="34541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CuadroTexto 10">
            <a:extLst>
              <a:ext uri="{FF2B5EF4-FFF2-40B4-BE49-F238E27FC236}">
                <a16:creationId xmlns:a16="http://schemas.microsoft.com/office/drawing/2014/main" id="{3993EF6B-3794-971B-10B1-146801AF1A93}"/>
              </a:ext>
            </a:extLst>
          </p:cNvPr>
          <p:cNvSpPr txBox="1"/>
          <p:nvPr/>
        </p:nvSpPr>
        <p:spPr>
          <a:xfrm rot="16200000">
            <a:off x="5317592" y="1733663"/>
            <a:ext cx="994451" cy="33906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WT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N546K 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N546K-R661P  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K656E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K656E-R661P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R661P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27B41E3F-D156-0012-B4D5-5AD87FBFAC11}"/>
              </a:ext>
            </a:extLst>
          </p:cNvPr>
          <p:cNvSpPr txBox="1"/>
          <p:nvPr/>
        </p:nvSpPr>
        <p:spPr>
          <a:xfrm>
            <a:off x="5585630" y="2562441"/>
            <a:ext cx="957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solidFill>
                  <a:srgbClr val="FF0000"/>
                </a:solidFill>
              </a:rPr>
              <a:t>Baf</a:t>
            </a:r>
            <a:r>
              <a:rPr lang="en-US" b="1" dirty="0">
                <a:solidFill>
                  <a:srgbClr val="FF0000"/>
                </a:solidFill>
              </a:rPr>
              <a:t> 24h</a:t>
            </a:r>
          </a:p>
        </p:txBody>
      </p:sp>
    </p:spTree>
    <p:extLst>
      <p:ext uri="{BB962C8B-B14F-4D97-AF65-F5344CB8AC3E}">
        <p14:creationId xmlns:p14="http://schemas.microsoft.com/office/powerpoint/2010/main" val="25715170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40C160A-EB60-1505-8194-A02FEF1987B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58CD7703-8141-8E86-16AB-54855494DF85}"/>
              </a:ext>
            </a:extLst>
          </p:cNvPr>
          <p:cNvSpPr txBox="1"/>
          <p:nvPr/>
        </p:nvSpPr>
        <p:spPr>
          <a:xfrm>
            <a:off x="370936" y="336430"/>
            <a:ext cx="468398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/>
              <a:t>4C</a:t>
            </a:r>
          </a:p>
        </p:txBody>
      </p:sp>
      <p:pic>
        <p:nvPicPr>
          <p:cNvPr id="4" name="Imagen 3" descr="Imagen que contiene interior, pastel, tabla, microondas&#10;&#10;El contenido generado por IA puede ser incorrecto.">
            <a:extLst>
              <a:ext uri="{FF2B5EF4-FFF2-40B4-BE49-F238E27FC236}">
                <a16:creationId xmlns:a16="http://schemas.microsoft.com/office/drawing/2014/main" id="{0160DA45-68FA-D05F-0086-A8FD59CB0B9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7224" y="923121"/>
            <a:ext cx="7200000" cy="5236364"/>
          </a:xfrm>
          <a:prstGeom prst="rect">
            <a:avLst/>
          </a:prstGeom>
        </p:spPr>
      </p:pic>
      <p:sp>
        <p:nvSpPr>
          <p:cNvPr id="5" name="Rectángulo 4">
            <a:extLst>
              <a:ext uri="{FF2B5EF4-FFF2-40B4-BE49-F238E27FC236}">
                <a16:creationId xmlns:a16="http://schemas.microsoft.com/office/drawing/2014/main" id="{2A630D8F-912E-F679-7150-D458A581353D}"/>
              </a:ext>
            </a:extLst>
          </p:cNvPr>
          <p:cNvSpPr/>
          <p:nvPr/>
        </p:nvSpPr>
        <p:spPr>
          <a:xfrm>
            <a:off x="3692641" y="2336571"/>
            <a:ext cx="4747974" cy="537258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182F5B67-B9C3-51FB-70D4-6BE36DFB84B5}"/>
              </a:ext>
            </a:extLst>
          </p:cNvPr>
          <p:cNvSpPr txBox="1"/>
          <p:nvPr/>
        </p:nvSpPr>
        <p:spPr>
          <a:xfrm rot="16200000">
            <a:off x="5218167" y="-843475"/>
            <a:ext cx="1784480" cy="45756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WT 0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WT 3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WT 6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 0h </a:t>
            </a: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 </a:t>
            </a: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 3h 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 6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-R661P 0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-R661P 3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-R661P 6h</a:t>
            </a:r>
          </a:p>
        </p:txBody>
      </p:sp>
      <p:sp>
        <p:nvSpPr>
          <p:cNvPr id="7" name="Rectángulo 6">
            <a:extLst>
              <a:ext uri="{FF2B5EF4-FFF2-40B4-BE49-F238E27FC236}">
                <a16:creationId xmlns:a16="http://schemas.microsoft.com/office/drawing/2014/main" id="{2B125C71-4FA7-FA64-5429-29EE30912A00}"/>
              </a:ext>
            </a:extLst>
          </p:cNvPr>
          <p:cNvSpPr/>
          <p:nvPr/>
        </p:nvSpPr>
        <p:spPr>
          <a:xfrm>
            <a:off x="3732833" y="4018650"/>
            <a:ext cx="4747974" cy="537258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2E66971B-2A21-BD58-6B28-BEC53064786D}"/>
              </a:ext>
            </a:extLst>
          </p:cNvPr>
          <p:cNvSpPr txBox="1"/>
          <p:nvPr/>
        </p:nvSpPr>
        <p:spPr>
          <a:xfrm>
            <a:off x="731147" y="2420534"/>
            <a:ext cx="1492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solidFill>
                  <a:srgbClr val="FF0000"/>
                </a:solidFill>
              </a:rPr>
              <a:t>FLAG-FGFR1</a:t>
            </a: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544CA7F9-C261-63E7-68DE-AD291C8BB4A0}"/>
              </a:ext>
            </a:extLst>
          </p:cNvPr>
          <p:cNvSpPr txBox="1"/>
          <p:nvPr/>
        </p:nvSpPr>
        <p:spPr>
          <a:xfrm>
            <a:off x="1199097" y="4135306"/>
            <a:ext cx="9619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solidFill>
                  <a:srgbClr val="FF0000"/>
                </a:solidFill>
              </a:rPr>
              <a:t>Tubulin</a:t>
            </a:r>
          </a:p>
        </p:txBody>
      </p:sp>
      <p:pic>
        <p:nvPicPr>
          <p:cNvPr id="10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A0DD2A80-CFCB-24DD-9EF8-C81B6BCEE37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51" t="7508" r="34356" b="40814"/>
          <a:stretch>
            <a:fillRect/>
          </a:stretch>
        </p:blipFill>
        <p:spPr bwMode="auto">
          <a:xfrm>
            <a:off x="9113093" y="1828041"/>
            <a:ext cx="2526211" cy="34541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6319892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CD56B1C-7D0A-53BE-6BF3-48B247105E7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n 7" descr="Imagen que contiene computadora, tabla, escritorio, monitor&#10;&#10;El contenido generado por IA puede ser incorrecto.">
            <a:extLst>
              <a:ext uri="{FF2B5EF4-FFF2-40B4-BE49-F238E27FC236}">
                <a16:creationId xmlns:a16="http://schemas.microsoft.com/office/drawing/2014/main" id="{AE97D57F-6552-EECC-63EE-E38B10B8C25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36547" y="705762"/>
            <a:ext cx="7200000" cy="5236364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F590D720-9682-A97A-1B5A-C30D73C145AC}"/>
              </a:ext>
            </a:extLst>
          </p:cNvPr>
          <p:cNvSpPr txBox="1"/>
          <p:nvPr/>
        </p:nvSpPr>
        <p:spPr>
          <a:xfrm>
            <a:off x="370936" y="336430"/>
            <a:ext cx="468398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/>
              <a:t>4C</a:t>
            </a:r>
          </a:p>
        </p:txBody>
      </p:sp>
      <p:sp>
        <p:nvSpPr>
          <p:cNvPr id="3" name="Rectángulo 2">
            <a:extLst>
              <a:ext uri="{FF2B5EF4-FFF2-40B4-BE49-F238E27FC236}">
                <a16:creationId xmlns:a16="http://schemas.microsoft.com/office/drawing/2014/main" id="{8F43E17C-FBCC-A684-8166-8CA19CE38A80}"/>
              </a:ext>
            </a:extLst>
          </p:cNvPr>
          <p:cNvSpPr/>
          <p:nvPr/>
        </p:nvSpPr>
        <p:spPr>
          <a:xfrm>
            <a:off x="3722013" y="3518389"/>
            <a:ext cx="4747974" cy="537258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AD4FFB9C-ADED-6A8F-25AC-0F3259A26D76}"/>
              </a:ext>
            </a:extLst>
          </p:cNvPr>
          <p:cNvSpPr txBox="1"/>
          <p:nvPr/>
        </p:nvSpPr>
        <p:spPr>
          <a:xfrm rot="16200000">
            <a:off x="5247539" y="338343"/>
            <a:ext cx="1784480" cy="45756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WT 0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WT 3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WT 6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 0h </a:t>
            </a: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 </a:t>
            </a: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 3h 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 6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-R661P 0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-R661P 3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-R661P 6h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212113FA-2BD5-9168-603D-A182496A88A0}"/>
              </a:ext>
            </a:extLst>
          </p:cNvPr>
          <p:cNvSpPr txBox="1"/>
          <p:nvPr/>
        </p:nvSpPr>
        <p:spPr>
          <a:xfrm>
            <a:off x="1688314" y="3602352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solidFill>
                  <a:srgbClr val="FF0000"/>
                </a:solidFill>
              </a:rPr>
              <a:t>ERK</a:t>
            </a:r>
          </a:p>
        </p:txBody>
      </p:sp>
      <p:pic>
        <p:nvPicPr>
          <p:cNvPr id="10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06B4300E-AC3F-582B-5930-AD4736E0D2C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51" t="36991" r="34356" b="34786"/>
          <a:stretch>
            <a:fillRect/>
          </a:stretch>
        </p:blipFill>
        <p:spPr bwMode="auto">
          <a:xfrm>
            <a:off x="8908332" y="2723997"/>
            <a:ext cx="2783780" cy="207882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76675097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6E175DB-1EF6-B5AC-4E3E-F453E953288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n 5" descr="Imagen que contiene refrigerador, camioneta, tabla, cocina&#10;&#10;El contenido generado por IA puede ser incorrecto.">
            <a:extLst>
              <a:ext uri="{FF2B5EF4-FFF2-40B4-BE49-F238E27FC236}">
                <a16:creationId xmlns:a16="http://schemas.microsoft.com/office/drawing/2014/main" id="{7FB62C9C-06C3-6F90-4C7D-96AB61C7A1A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5487" y="705762"/>
            <a:ext cx="7200000" cy="5236364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B90D7C2F-CA48-48E6-3D52-89B1A653C070}"/>
              </a:ext>
            </a:extLst>
          </p:cNvPr>
          <p:cNvSpPr txBox="1"/>
          <p:nvPr/>
        </p:nvSpPr>
        <p:spPr>
          <a:xfrm>
            <a:off x="370936" y="336430"/>
            <a:ext cx="468398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/>
              <a:t>4C</a:t>
            </a:r>
          </a:p>
        </p:txBody>
      </p:sp>
      <p:sp>
        <p:nvSpPr>
          <p:cNvPr id="3" name="Rectángulo 2">
            <a:extLst>
              <a:ext uri="{FF2B5EF4-FFF2-40B4-BE49-F238E27FC236}">
                <a16:creationId xmlns:a16="http://schemas.microsoft.com/office/drawing/2014/main" id="{2298320D-C088-DA76-F0B5-29B9E93B3BDE}"/>
              </a:ext>
            </a:extLst>
          </p:cNvPr>
          <p:cNvSpPr/>
          <p:nvPr/>
        </p:nvSpPr>
        <p:spPr>
          <a:xfrm>
            <a:off x="3899674" y="3777182"/>
            <a:ext cx="4747974" cy="537258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FC2FDFEF-6916-B65D-62BC-DBC394D85AA6}"/>
              </a:ext>
            </a:extLst>
          </p:cNvPr>
          <p:cNvSpPr txBox="1"/>
          <p:nvPr/>
        </p:nvSpPr>
        <p:spPr>
          <a:xfrm>
            <a:off x="1545685" y="3945108"/>
            <a:ext cx="742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err="1">
                <a:solidFill>
                  <a:srgbClr val="FF0000"/>
                </a:solidFill>
              </a:rPr>
              <a:t>pERK</a:t>
            </a:r>
            <a:endParaRPr lang="en-US" b="1">
              <a:solidFill>
                <a:srgbClr val="FF0000"/>
              </a:solidFill>
            </a:endParaRP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ECD0E035-7789-CFCA-2FF9-123598A2EDE1}"/>
              </a:ext>
            </a:extLst>
          </p:cNvPr>
          <p:cNvSpPr txBox="1"/>
          <p:nvPr/>
        </p:nvSpPr>
        <p:spPr>
          <a:xfrm rot="16200000">
            <a:off x="5381421" y="597136"/>
            <a:ext cx="1784480" cy="45756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WT 0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WT 3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WT 6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 0h </a:t>
            </a: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 </a:t>
            </a: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 3h 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 6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-R661P 0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-R661P 3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-R661P 6h</a:t>
            </a:r>
          </a:p>
        </p:txBody>
      </p:sp>
      <p:pic>
        <p:nvPicPr>
          <p:cNvPr id="10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D7276146-AF24-0749-CC60-0A0A8679E6A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51" t="36991" r="34356" b="34786"/>
          <a:stretch>
            <a:fillRect/>
          </a:stretch>
        </p:blipFill>
        <p:spPr bwMode="auto">
          <a:xfrm>
            <a:off x="9068130" y="3006400"/>
            <a:ext cx="2783780" cy="207882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32462912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17576DA-56EE-95B4-F0CC-2DF5AEEA787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n 5" descr="Imagen que contiene interior, tabla, microondas, horno&#10;&#10;El contenido generado por IA puede ser incorrecto.">
            <a:extLst>
              <a:ext uri="{FF2B5EF4-FFF2-40B4-BE49-F238E27FC236}">
                <a16:creationId xmlns:a16="http://schemas.microsoft.com/office/drawing/2014/main" id="{4D7C3AE0-5E9F-AE6F-153A-C18902130F6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3307" y="1425597"/>
            <a:ext cx="7200000" cy="5236364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734C43C1-0BEA-BD77-F9A2-C04B416D5CF6}"/>
              </a:ext>
            </a:extLst>
          </p:cNvPr>
          <p:cNvSpPr txBox="1"/>
          <p:nvPr/>
        </p:nvSpPr>
        <p:spPr>
          <a:xfrm>
            <a:off x="370936" y="336430"/>
            <a:ext cx="436338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lIns="91440" tIns="45720" rIns="91440" bIns="45720" rtlCol="0" anchor="t">
            <a:spAutoFit/>
          </a:bodyPr>
          <a:lstStyle/>
          <a:p>
            <a:r>
              <a:rPr lang="en-US"/>
              <a:t>4E</a:t>
            </a:r>
          </a:p>
        </p:txBody>
      </p:sp>
      <p:sp>
        <p:nvSpPr>
          <p:cNvPr id="3" name="Rectángulo 2">
            <a:extLst>
              <a:ext uri="{FF2B5EF4-FFF2-40B4-BE49-F238E27FC236}">
                <a16:creationId xmlns:a16="http://schemas.microsoft.com/office/drawing/2014/main" id="{FB428063-C6B9-1939-DCFB-47CABB6EABBF}"/>
              </a:ext>
            </a:extLst>
          </p:cNvPr>
          <p:cNvSpPr/>
          <p:nvPr/>
        </p:nvSpPr>
        <p:spPr>
          <a:xfrm>
            <a:off x="3549320" y="2545593"/>
            <a:ext cx="4747974" cy="537258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DE53DB8A-6B05-49EA-5EEE-806BD77DCD7F}"/>
              </a:ext>
            </a:extLst>
          </p:cNvPr>
          <p:cNvSpPr txBox="1"/>
          <p:nvPr/>
        </p:nvSpPr>
        <p:spPr>
          <a:xfrm rot="16200000">
            <a:off x="5044096" y="1698338"/>
            <a:ext cx="1784480" cy="45756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WT </a:t>
            </a:r>
          </a:p>
          <a:p>
            <a:pPr algn="r"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 algn="r"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WT </a:t>
            </a:r>
          </a:p>
          <a:p>
            <a:pPr algn="r"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 algn="r"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WT </a:t>
            </a:r>
          </a:p>
          <a:p>
            <a:pPr algn="r"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 algn="r"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K656E</a:t>
            </a:r>
          </a:p>
          <a:p>
            <a:pPr algn="r"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 </a:t>
            </a:r>
          </a:p>
          <a:p>
            <a:pPr algn="r"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K656E </a:t>
            </a:r>
          </a:p>
          <a:p>
            <a:pPr algn="r"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 algn="r"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K656E</a:t>
            </a:r>
          </a:p>
          <a:p>
            <a:pPr algn="r"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 algn="r"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K656E-R661P </a:t>
            </a:r>
          </a:p>
          <a:p>
            <a:pPr algn="r"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 algn="r"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K656E-R661P </a:t>
            </a:r>
          </a:p>
          <a:p>
            <a:pPr algn="r"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 algn="r"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K656E-R661P 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1559F178-F42D-FE49-0962-3CF5EEDA5B21}"/>
              </a:ext>
            </a:extLst>
          </p:cNvPr>
          <p:cNvSpPr txBox="1"/>
          <p:nvPr/>
        </p:nvSpPr>
        <p:spPr>
          <a:xfrm>
            <a:off x="697528" y="2711867"/>
            <a:ext cx="1492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solidFill>
                  <a:srgbClr val="FF0000"/>
                </a:solidFill>
              </a:rPr>
              <a:t>FLAG-FGFR1</a:t>
            </a:r>
          </a:p>
        </p:txBody>
      </p:sp>
      <p:pic>
        <p:nvPicPr>
          <p:cNvPr id="8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79B85FC6-2912-C85D-163A-3245A1E42F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51" t="7508" r="34356" b="63257"/>
          <a:stretch>
            <a:fillRect/>
          </a:stretch>
        </p:blipFill>
        <p:spPr bwMode="auto">
          <a:xfrm>
            <a:off x="8573414" y="2226620"/>
            <a:ext cx="1732121" cy="13398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Gráfico 10">
            <a:extLst>
              <a:ext uri="{FF2B5EF4-FFF2-40B4-BE49-F238E27FC236}">
                <a16:creationId xmlns:a16="http://schemas.microsoft.com/office/drawing/2014/main" id="{FAE77159-42A0-D4B3-3239-10F91C9377D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2653295" y="922202"/>
            <a:ext cx="5853492" cy="16123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419241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9DB6D2E-3AF2-4857-32AF-49BBE461ADA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 descr="Imagen que contiene monitor, microondas, horno&#10;&#10;El contenido generado por IA puede ser incorrecto.">
            <a:extLst>
              <a:ext uri="{FF2B5EF4-FFF2-40B4-BE49-F238E27FC236}">
                <a16:creationId xmlns:a16="http://schemas.microsoft.com/office/drawing/2014/main" id="{8AF12BB6-B2FE-7C1D-7B4C-4E7CE571CD2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6617" y="988804"/>
            <a:ext cx="7200000" cy="5236364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9DB56649-E52C-84B0-B180-352ADC0A5B4F}"/>
              </a:ext>
            </a:extLst>
          </p:cNvPr>
          <p:cNvSpPr txBox="1"/>
          <p:nvPr/>
        </p:nvSpPr>
        <p:spPr>
          <a:xfrm>
            <a:off x="370936" y="336430"/>
            <a:ext cx="436338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lIns="91440" tIns="45720" rIns="91440" bIns="45720" rtlCol="0" anchor="t">
            <a:spAutoFit/>
          </a:bodyPr>
          <a:lstStyle/>
          <a:p>
            <a:r>
              <a:rPr lang="en-US"/>
              <a:t>4E</a:t>
            </a:r>
          </a:p>
        </p:txBody>
      </p:sp>
      <p:sp>
        <p:nvSpPr>
          <p:cNvPr id="7" name="Rectángulo 6">
            <a:extLst>
              <a:ext uri="{FF2B5EF4-FFF2-40B4-BE49-F238E27FC236}">
                <a16:creationId xmlns:a16="http://schemas.microsoft.com/office/drawing/2014/main" id="{69D118A3-2C40-48EF-F39B-B58E2D9DDD49}"/>
              </a:ext>
            </a:extLst>
          </p:cNvPr>
          <p:cNvSpPr/>
          <p:nvPr/>
        </p:nvSpPr>
        <p:spPr>
          <a:xfrm>
            <a:off x="2820441" y="3594629"/>
            <a:ext cx="4747974" cy="537258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7B4461AB-130A-DA97-2591-0D98072AAE42}"/>
              </a:ext>
            </a:extLst>
          </p:cNvPr>
          <p:cNvSpPr txBox="1"/>
          <p:nvPr/>
        </p:nvSpPr>
        <p:spPr>
          <a:xfrm>
            <a:off x="534050" y="3762555"/>
            <a:ext cx="9619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solidFill>
                  <a:srgbClr val="FF0000"/>
                </a:solidFill>
              </a:rPr>
              <a:t>Tubulin</a:t>
            </a:r>
          </a:p>
        </p:txBody>
      </p:sp>
      <p:pic>
        <p:nvPicPr>
          <p:cNvPr id="11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0B271B25-1880-FB20-8BF3-AB48D027EAF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51" t="36991" r="34356" b="41663"/>
          <a:stretch>
            <a:fillRect/>
          </a:stretch>
        </p:blipFill>
        <p:spPr bwMode="auto">
          <a:xfrm>
            <a:off x="8167294" y="3345740"/>
            <a:ext cx="2783780" cy="157229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CuadroTexto 2">
            <a:extLst>
              <a:ext uri="{FF2B5EF4-FFF2-40B4-BE49-F238E27FC236}">
                <a16:creationId xmlns:a16="http://schemas.microsoft.com/office/drawing/2014/main" id="{4C0260FE-7A5F-72F3-46DD-BAAAF2737024}"/>
              </a:ext>
            </a:extLst>
          </p:cNvPr>
          <p:cNvSpPr txBox="1"/>
          <p:nvPr/>
        </p:nvSpPr>
        <p:spPr>
          <a:xfrm rot="16200000">
            <a:off x="4347908" y="414583"/>
            <a:ext cx="1784480" cy="45756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WT </a:t>
            </a: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WT </a:t>
            </a: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WT </a:t>
            </a: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K656E</a:t>
            </a: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 </a:t>
            </a: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K656E </a:t>
            </a: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K656E</a:t>
            </a: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K656E-R661P </a:t>
            </a: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K656E-R661P </a:t>
            </a: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K656E-R661P </a:t>
            </a:r>
          </a:p>
        </p:txBody>
      </p:sp>
      <p:pic>
        <p:nvPicPr>
          <p:cNvPr id="5" name="Gráfico 4">
            <a:extLst>
              <a:ext uri="{FF2B5EF4-FFF2-40B4-BE49-F238E27FC236}">
                <a16:creationId xmlns:a16="http://schemas.microsoft.com/office/drawing/2014/main" id="{7B893448-0FA0-7374-8B10-99B24E8BE69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967495" y="803276"/>
            <a:ext cx="5853492" cy="16123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8915411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ptos" panose="020B000402020202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3b06b1ac-b6cc-4c25-bfb7-551e20c80d5c">
      <Terms xmlns="http://schemas.microsoft.com/office/infopath/2007/PartnerControls"/>
    </lcf76f155ced4ddcb4097134ff3c332f>
    <_ip_UnifiedCompliancePolicyUIAction xmlns="http://schemas.microsoft.com/sharepoint/v3" xsi:nil="true"/>
    <_ip_UnifiedCompliancePolicyProperties xmlns="http://schemas.microsoft.com/sharepoint/v3" xsi:nil="true"/>
    <experiment xmlns="3b06b1ac-b6cc-4c25-bfb7-551e20c80d5c" xsi:nil="true"/>
    <TaxCatchAll xmlns="e060ecb7-dcf7-4a45-ada8-96d79a1fb1be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82784A8EC112FF47A12A49FA34F89301" ma:contentTypeVersion="19" ma:contentTypeDescription="Crear nuevo documento." ma:contentTypeScope="" ma:versionID="3a523e80048e49ca689ccbbead60cdeb">
  <xsd:schema xmlns:xsd="http://www.w3.org/2001/XMLSchema" xmlns:xs="http://www.w3.org/2001/XMLSchema" xmlns:p="http://schemas.microsoft.com/office/2006/metadata/properties" xmlns:ns1="http://schemas.microsoft.com/sharepoint/v3" xmlns:ns2="3b06b1ac-b6cc-4c25-bfb7-551e20c80d5c" xmlns:ns3="e060ecb7-dcf7-4a45-ada8-96d79a1fb1be" targetNamespace="http://schemas.microsoft.com/office/2006/metadata/properties" ma:root="true" ma:fieldsID="bb7710ec5d278677887808aadfeb7836" ns1:_="" ns2:_="" ns3:_="">
    <xsd:import namespace="http://schemas.microsoft.com/sharepoint/v3"/>
    <xsd:import namespace="3b06b1ac-b6cc-4c25-bfb7-551e20c80d5c"/>
    <xsd:import namespace="e060ecb7-dcf7-4a45-ada8-96d79a1fb1be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  <xsd:element ref="ns2:MediaServiceDateTaken" minOccurs="0"/>
                <xsd:element ref="ns2:MediaServiceLocation" minOccurs="0"/>
                <xsd:element ref="ns2:MediaServiceGenerationTime" minOccurs="0"/>
                <xsd:element ref="ns2:MediaServiceEventHashCode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3:SharedWithUsers" minOccurs="0"/>
                <xsd:element ref="ns3:SharedWithDetails" minOccurs="0"/>
                <xsd:element ref="ns2:experiment" minOccurs="0"/>
                <xsd:element ref="ns1:_ip_UnifiedCompliancePolicyProperties" minOccurs="0"/>
                <xsd:element ref="ns1:_ip_UnifiedCompliancePolicyUIAction" minOccurs="0"/>
                <xsd:element ref="ns2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24" nillable="true" ma:displayName="Propiedades de la Directiva de cumplimiento unificado" ma:hidden="true" ma:internalName="_ip_UnifiedCompliancePolicyProperties">
      <xsd:simpleType>
        <xsd:restriction base="dms:Note"/>
      </xsd:simpleType>
    </xsd:element>
    <xsd:element name="_ip_UnifiedCompliancePolicyUIAction" ma:index="25" nillable="true" ma:displayName="Acción de IU de la Directiva de cumplimiento unificado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b06b1ac-b6cc-4c25-bfb7-551e20c80d5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DateTaken" ma:index="12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Location" ma:index="13" nillable="true" ma:displayName="Location" ma:indexed="true" ma:internalName="MediaServiceLocation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6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18" nillable="true" ma:taxonomy="true" ma:internalName="lcf76f155ced4ddcb4097134ff3c332f" ma:taxonomyFieldName="MediaServiceImageTags" ma:displayName="Etiquetas de imagen" ma:readOnly="false" ma:fieldId="{5cf76f15-5ced-4ddc-b409-7134ff3c332f}" ma:taxonomyMulti="true" ma:sspId="060dc275-4b37-4471-97cc-e467d34dad9d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20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experiment" ma:index="23" nillable="true" ma:displayName="experiment" ma:format="Dropdown" ma:internalName="experiment">
      <xsd:simpleType>
        <xsd:restriction base="dms:Text">
          <xsd:maxLength value="255"/>
        </xsd:restriction>
      </xsd:simpleType>
    </xsd:element>
    <xsd:element name="MediaServiceBillingMetadata" ma:index="26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060ecb7-dcf7-4a45-ada8-96d79a1fb1be" elementFormDefault="qualified">
    <xsd:import namespace="http://schemas.microsoft.com/office/2006/documentManagement/types"/>
    <xsd:import namespace="http://schemas.microsoft.com/office/infopath/2007/PartnerControls"/>
    <xsd:element name="TaxCatchAll" ma:index="19" nillable="true" ma:displayName="Taxonomy Catch All Column" ma:hidden="true" ma:list="{e1f92d22-2900-48ef-9cf0-36df0f5fa8f8}" ma:internalName="TaxCatchAll" ma:showField="CatchAllData" ma:web="e060ecb7-dcf7-4a45-ada8-96d79a1fb1be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21" nillable="true" ma:displayName="Compartid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2" nillable="true" ma:displayName="Detalles de uso compartido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ni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3F7AEF27-12CF-4E6A-A4C3-0C70AB873B03}">
  <ds:schemaRefs>
    <ds:schemaRef ds:uri="3b06b1ac-b6cc-4c25-bfb7-551e20c80d5c"/>
    <ds:schemaRef ds:uri="e060ecb7-dcf7-4a45-ada8-96d79a1fb1be"/>
    <ds:schemaRef ds:uri="http://schemas.microsoft.com/office/2006/metadata/properties"/>
    <ds:schemaRef ds:uri="http://schemas.microsoft.com/office/infopath/2007/PartnerControls"/>
    <ds:schemaRef ds:uri="http://schemas.microsoft.com/sharepoint/v3"/>
  </ds:schemaRefs>
</ds:datastoreItem>
</file>

<file path=customXml/itemProps2.xml><?xml version="1.0" encoding="utf-8"?>
<ds:datastoreItem xmlns:ds="http://schemas.openxmlformats.org/officeDocument/2006/customXml" ds:itemID="{19958082-6C40-488A-8135-0A38B0E6EB72}">
  <ds:schemaRefs>
    <ds:schemaRef ds:uri="3b06b1ac-b6cc-4c25-bfb7-551e20c80d5c"/>
    <ds:schemaRef ds:uri="e060ecb7-dcf7-4a45-ada8-96d79a1fb1be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microsoft.com/sharepoint/v3"/>
    <ds:schemaRef ds:uri="http://schemas.openxmlformats.org/package/2006/metadata/core-properties"/>
    <ds:schemaRef ds:uri="http://www.w3.org/2001/XMLSchema"/>
  </ds:schemaRefs>
</ds:datastoreItem>
</file>

<file path=customXml/itemProps3.xml><?xml version="1.0" encoding="utf-8"?>
<ds:datastoreItem xmlns:ds="http://schemas.openxmlformats.org/officeDocument/2006/customXml" ds:itemID="{B975D885-2EFD-43D8-9F27-DFF974AB0B7B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8</Words>
  <Application>Microsoft Office PowerPoint</Application>
  <PresentationFormat>Panorámica</PresentationFormat>
  <Paragraphs>141</Paragraphs>
  <Slides>8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8</vt:i4>
      </vt:variant>
    </vt:vector>
  </HeadingPairs>
  <TitlesOfParts>
    <vt:vector size="12" baseType="lpstr">
      <vt:lpstr>Aptos</vt:lpstr>
      <vt:lpstr>Aptos Display</vt:lpstr>
      <vt:lpstr>Arial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Jacopo Boni</cp:lastModifiedBy>
  <cp:revision>1</cp:revision>
  <dcterms:created xsi:type="dcterms:W3CDTF">2025-07-23T10:06:09Z</dcterms:created>
  <dcterms:modified xsi:type="dcterms:W3CDTF">2025-09-08T15:15:1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2784A8EC112FF47A12A49FA34F89301</vt:lpwstr>
  </property>
  <property fmtid="{D5CDD505-2E9C-101B-9397-08002B2CF9AE}" pid="3" name="MediaServiceImageTags">
    <vt:lpwstr/>
  </property>
</Properties>
</file>